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0890" autoAdjust="0"/>
  </p:normalViewPr>
  <p:slideViewPr>
    <p:cSldViewPr snapToGrid="0">
      <p:cViewPr varScale="1">
        <p:scale>
          <a:sx n="54" d="100"/>
          <a:sy n="54" d="100"/>
        </p:scale>
        <p:origin x="114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FF5761-10B4-49DB-A255-67832C904F4F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50B30C-BC22-41FA-A12C-82805BC5642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1584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CH"/>
              <a:t>S2. </a:t>
            </a:r>
            <a:r>
              <a:rPr lang="de-CH" dirty="0" err="1"/>
              <a:t>Markerset</a:t>
            </a:r>
            <a:r>
              <a:rPr lang="de-CH" dirty="0"/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50B30C-BC22-41FA-A12C-82805BC5642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0233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231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255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058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324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549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3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116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489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08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502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161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F6A786-73C1-4726-8F2D-5020902E9219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A540D-3494-4824-AB7D-411DCBD9B2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495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181" y="138921"/>
            <a:ext cx="5232400" cy="4252595"/>
          </a:xfrm>
          <a:prstGeom prst="rect">
            <a:avLst/>
          </a:prstGeom>
          <a:noFill/>
        </p:spPr>
      </p:pic>
      <p:pic>
        <p:nvPicPr>
          <p:cNvPr id="6" name="Picture 5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2" t="55015"/>
          <a:stretch/>
        </p:blipFill>
        <p:spPr bwMode="auto">
          <a:xfrm>
            <a:off x="173181" y="4686184"/>
            <a:ext cx="2597728" cy="130821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362"/>
          <a:stretch/>
        </p:blipFill>
        <p:spPr bwMode="auto">
          <a:xfrm>
            <a:off x="3241472" y="4582448"/>
            <a:ext cx="1746164" cy="170751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5260769" y="138921"/>
            <a:ext cx="3165103" cy="6555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ventional Gait Model 1.0:</a:t>
            </a: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FHD/RFHD: Left/Right front head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HD/RBHD: Left/Right Back Head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HO/RSHO: Left/Right Shoulder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romi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avicular joint)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V: Where the clavicle meets the sternum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7: 7th Cervical Vertebra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AK: Left Back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10: 10th Thoracic Vertebra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N: Xiphoid process of the Sternum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LB/RELB: Left/Right Elbow (lateral epicondyle)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WRA/RWRA: Left/Right Wrist thumb side</a:t>
            </a:r>
            <a:endParaRPr lang="en-US" sz="12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WRB/RWRB: Left/Right Wrist pinkie side</a:t>
            </a:r>
            <a:endParaRPr lang="en-US" sz="12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FIN/RFIN: Left/Right Dorsum of the hand</a:t>
            </a:r>
            <a:endParaRPr lang="en-US" sz="12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I/RASI: Left/Right Anterior Superior Iliac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SI/RPSI: Left/Right Posterior Superior Iliac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CR: Sacrum (middle of the LPSI/RPSI)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THI/RTHI: Left/Right lateral Thigh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KNE/RKNE: Left/Right Knee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TIB/RTIB: Left/Right lateral Tibia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KM/RANKM: Left/Right Medial Malleoli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K/RANK: Left/Right lateral Malleoli</a:t>
            </a:r>
            <a:endParaRPr lang="en-US" sz="12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EE/RHEE: Left/Right Heel (same level as the TOE marker)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TOE/RTOE: Left/Right Metatarsal II head</a:t>
            </a:r>
            <a:endParaRPr lang="en-US" sz="12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269546" y="138921"/>
            <a:ext cx="3416763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Markers: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TRO/RTRO: Left/Right Trochanter Major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THI/RDTHI: Left/Right Distal posterior Thigh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THI/RPTHI: Left/Right Proximal anterior Thigh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TUB/RTUB: Left/Righ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bi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berosity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TIB/RDTIB: Left/Right Medial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bi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dge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ITA/RSITA: Left/Right Sinus Tarsi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TR/RPTR: Placed under ankle, lateral on the calcaneus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MT5/RPMT5: Left/Right Metatarsal V ba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TM1/RPTM1: Left/Right Metatarsal I base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UN/RCUN: Placed between Metatarsal I and V basis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MT5/RDMT5: Left/Right Metatarsal V head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MT1/RDMT1: Left/Right Metatarsal I head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LX/RHLX: Left/Right Hallux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1544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3</Words>
  <Application>Microsoft Office PowerPoint</Application>
  <PresentationFormat>Breitbild</PresentationFormat>
  <Paragraphs>41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>ETH-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sscher  Rosa</dc:creator>
  <cp:lastModifiedBy>Visscher  Rosa</cp:lastModifiedBy>
  <cp:revision>12</cp:revision>
  <dcterms:created xsi:type="dcterms:W3CDTF">2020-05-29T10:47:07Z</dcterms:created>
  <dcterms:modified xsi:type="dcterms:W3CDTF">2021-08-31T13:21:35Z</dcterms:modified>
</cp:coreProperties>
</file>